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81" d="100"/>
          <a:sy n="81" d="100"/>
        </p:scale>
        <p:origin x="33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FFAC41BD-C9B1-4FC1-9479-CF4B2A3CB6E1}"/>
    <pc:docChg chg="modSld">
      <pc:chgData name="임승혁" userId="50080d77-0d6e-4880-96a7-58e4dd6aba5c" providerId="ADAL" clId="{FFAC41BD-C9B1-4FC1-9479-CF4B2A3CB6E1}" dt="2023-07-03T03:20:08.428" v="2" actId="20577"/>
      <pc:docMkLst>
        <pc:docMk/>
      </pc:docMkLst>
      <pc:sldChg chg="modSp mod">
        <pc:chgData name="임승혁" userId="50080d77-0d6e-4880-96a7-58e4dd6aba5c" providerId="ADAL" clId="{FFAC41BD-C9B1-4FC1-9479-CF4B2A3CB6E1}" dt="2023-07-03T03:20:08.428" v="2" actId="20577"/>
        <pc:sldMkLst>
          <pc:docMk/>
          <pc:sldMk cId="3431822228" sldId="256"/>
        </pc:sldMkLst>
        <pc:spChg chg="mod">
          <ac:chgData name="임승혁" userId="50080d77-0d6e-4880-96a7-58e4dd6aba5c" providerId="ADAL" clId="{FFAC41BD-C9B1-4FC1-9479-CF4B2A3CB6E1}" dt="2023-07-03T03:20:08.428" v="2" actId="20577"/>
          <ac:spMkLst>
            <pc:docMk/>
            <pc:sldMk cId="3431822228" sldId="256"/>
            <ac:spMk id="5" creationId="{A2B06BF4-8BA6-EA6E-3403-93919840A4E6}"/>
          </ac:spMkLst>
        </pc:spChg>
      </pc:sldChg>
    </pc:docChg>
  </pc:docChgLst>
  <pc:docChgLst>
    <pc:chgData name="임승혁" userId="50080d77-0d6e-4880-96a7-58e4dd6aba5c" providerId="ADAL" clId="{0F7F004F-0320-47A6-AC00-A9B5AD648CFC}"/>
    <pc:docChg chg="modSld">
      <pc:chgData name="임승혁" userId="50080d77-0d6e-4880-96a7-58e4dd6aba5c" providerId="ADAL" clId="{0F7F004F-0320-47A6-AC00-A9B5AD648CFC}" dt="2023-06-30T00:20:17.406" v="1" actId="20577"/>
      <pc:docMkLst>
        <pc:docMk/>
      </pc:docMkLst>
      <pc:sldChg chg="modSp mod">
        <pc:chgData name="임승혁" userId="50080d77-0d6e-4880-96a7-58e4dd6aba5c" providerId="ADAL" clId="{0F7F004F-0320-47A6-AC00-A9B5AD648CFC}" dt="2023-06-30T00:20:17.406" v="1" actId="20577"/>
        <pc:sldMkLst>
          <pc:docMk/>
          <pc:sldMk cId="3431822228" sldId="256"/>
        </pc:sldMkLst>
        <pc:spChg chg="mod">
          <ac:chgData name="임승혁" userId="50080d77-0d6e-4880-96a7-58e4dd6aba5c" providerId="ADAL" clId="{0F7F004F-0320-47A6-AC00-A9B5AD648CFC}" dt="2023-06-30T00:20:17.406" v="1" actId="20577"/>
          <ac:spMkLst>
            <pc:docMk/>
            <pc:sldMk cId="3431822228" sldId="256"/>
            <ac:spMk id="5" creationId="{A2B06BF4-8BA6-EA6E-3403-93919840A4E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15" b="2115"/>
          <a:stretch/>
        </p:blipFill>
        <p:spPr bwMode="auto">
          <a:xfrm>
            <a:off x="976045" y="904125"/>
            <a:ext cx="7037798" cy="580294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9219"/>
            <a:ext cx="8753273" cy="786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6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</a:t>
            </a:r>
            <a:r>
              <a:rPr lang="en-US" altLang="ko-KR" sz="16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tent 10. </a:t>
            </a:r>
            <a:r>
              <a:rPr lang="en-US" altLang="ko-KR" sz="16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verall survival after living-donor liver transplantation and deceased-donor liver transplantation, after Inverted Probability Treatment Weighting.</a:t>
            </a:r>
            <a:endParaRPr lang="ko-KR" altLang="ko-KR" sz="16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769335"/>
            <a:ext cx="8753273" cy="610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DLT, living-donor liver transplantation; DDLT, Deceased-donor liver transplantation; MELD, Model for End-stage Liver Disease.</a:t>
            </a:r>
            <a:endParaRPr lang="ko-KR" altLang="ko-KR" sz="11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/>
          <p:nvPr/>
        </p:nvCxnSpPr>
        <p:spPr>
          <a:xfrm>
            <a:off x="134936" y="6769335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7</TotalTime>
  <Words>43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2</cp:revision>
  <dcterms:created xsi:type="dcterms:W3CDTF">2023-05-09T01:23:50Z</dcterms:created>
  <dcterms:modified xsi:type="dcterms:W3CDTF">2023-07-03T03:20:09Z</dcterms:modified>
</cp:coreProperties>
</file>